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907588" cy="6858000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796800" cy="9925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49840" y="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711000" y="744120"/>
            <a:ext cx="5375160" cy="37227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79320" y="471456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427680"/>
            <a:ext cx="2946240" cy="497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49840" y="9427680"/>
            <a:ext cx="2946240" cy="497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82C0D14-1494-415C-9E83-B76C4ACDB9D5}" type="slidenum">
              <a:rPr b="0" lang="ja-JP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1" name="PlaceHolder 1"/>
          <p:cNvSpPr>
            <a:spLocks noGrp="1"/>
          </p:cNvSpPr>
          <p:nvPr>
            <p:ph type="sldImg"/>
          </p:nvPr>
        </p:nvSpPr>
        <p:spPr>
          <a:xfrm>
            <a:off x="711360" y="744480"/>
            <a:ext cx="5375160" cy="3722760"/>
          </a:xfrm>
          <a:prstGeom prst="rect">
            <a:avLst/>
          </a:prstGeom>
          <a:ln w="0">
            <a:noFill/>
          </a:ln>
        </p:spPr>
      </p:sp>
      <p:sp>
        <p:nvSpPr>
          <p:cNvPr id="232" name="PlaceHolder 2"/>
          <p:cNvSpPr>
            <a:spLocks noGrp="1"/>
          </p:cNvSpPr>
          <p:nvPr>
            <p:ph type="body"/>
          </p:nvPr>
        </p:nvSpPr>
        <p:spPr>
          <a:xfrm>
            <a:off x="679320" y="471456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lnSpc>
                <a:spcPct val="100000"/>
              </a:lnSpc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ffects of ds-miR-655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purchased from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harmacon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3" name="スライド番号プレースホルダー 3"/>
          <p:cNvSpPr/>
          <p:nvPr/>
        </p:nvSpPr>
        <p:spPr>
          <a:xfrm>
            <a:off x="3849840" y="9428040"/>
            <a:ext cx="2946240" cy="497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CDF3ACC-D764-41F8-B368-CCA92A76B617}" type="slidenum">
              <a:rPr b="0" lang="ja-JP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20B2F6-A03F-4B5E-BC78-7BF30A8302C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89154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95000" y="3964320"/>
            <a:ext cx="89154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1ECAB8-75D1-41AA-BB3B-9C31A0CB9B3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950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50634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8D4ED9-7136-43DE-B61A-A29B812E266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509640" y="160020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524280" y="160020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95000" y="396432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509640" y="396432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524280" y="396432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BFCC66-77A0-4C15-861B-A6CA02B10ED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95000" y="1600200"/>
            <a:ext cx="89154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D7EB48-905B-48B0-A1B6-A9B0FE59952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89154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E7BE27-AE94-45BA-A9F5-B199678B8A7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2B5570-F314-424F-952F-E2B20486F26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794977-B84A-4C5D-AF12-63BAFDB44CC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95000" y="274320"/>
            <a:ext cx="8915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CB27A1-3989-4E4D-B89B-2F743ABE94C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950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BE220A-9713-4F94-9D56-AE0C1AD81D7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50634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57ED89-6A81-4D64-A59E-91F4C0D551F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95000" y="3964320"/>
            <a:ext cx="89154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9E4BF5-5E70-4538-8691-9FE662334C5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95000" y="1600200"/>
            <a:ext cx="89154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95360" y="6356520"/>
            <a:ext cx="2311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Arial"/>
                <a:ea typeface="HGSｺﾞｼｯｸE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Arial"/>
                <a:ea typeface="HGSｺﾞｼｯｸE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384360" y="6356520"/>
            <a:ext cx="31366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7098840" y="6356520"/>
            <a:ext cx="231156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Arial"/>
                <a:ea typeface="HGSｺﾞｼｯｸE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63A2706-B613-4039-9360-C85C27F37F6A}" type="slidenum">
              <a:rPr b="0" lang="ja-JP" sz="1200" spc="-1" strike="noStrike">
                <a:solidFill>
                  <a:srgbClr val="898989"/>
                </a:solidFill>
                <a:latin typeface="Arial"/>
                <a:ea typeface="HGSｺﾞｼｯｸE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テキスト ボックス 97"/>
          <p:cNvSpPr/>
          <p:nvPr/>
        </p:nvSpPr>
        <p:spPr>
          <a:xfrm>
            <a:off x="146160" y="139680"/>
            <a:ext cx="231408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. 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正方形/長方形 138"/>
          <p:cNvSpPr/>
          <p:nvPr/>
        </p:nvSpPr>
        <p:spPr>
          <a:xfrm>
            <a:off x="1488960" y="1278000"/>
            <a:ext cx="7077240" cy="1896840"/>
          </a:xfrm>
          <a:prstGeom prst="rect">
            <a:avLst/>
          </a:prstGeom>
          <a:noFill/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直線コネクタ 139"/>
          <p:cNvSpPr/>
          <p:nvPr/>
        </p:nvSpPr>
        <p:spPr>
          <a:xfrm>
            <a:off x="1365120" y="1395360"/>
            <a:ext cx="12384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直線コネクタ 140"/>
          <p:cNvSpPr/>
          <p:nvPr/>
        </p:nvSpPr>
        <p:spPr>
          <a:xfrm>
            <a:off x="1365120" y="1994040"/>
            <a:ext cx="12384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直線コネクタ 141"/>
          <p:cNvSpPr/>
          <p:nvPr/>
        </p:nvSpPr>
        <p:spPr>
          <a:xfrm>
            <a:off x="1365120" y="2587680"/>
            <a:ext cx="12384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直線コネクタ 142"/>
          <p:cNvSpPr/>
          <p:nvPr/>
        </p:nvSpPr>
        <p:spPr>
          <a:xfrm>
            <a:off x="1365120" y="3174840"/>
            <a:ext cx="12384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直線コネクタ 118"/>
          <p:cNvSpPr/>
          <p:nvPr/>
        </p:nvSpPr>
        <p:spPr>
          <a:xfrm>
            <a:off x="1590840" y="1965240"/>
            <a:ext cx="7128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直線コネクタ 128"/>
          <p:cNvSpPr/>
          <p:nvPr/>
        </p:nvSpPr>
        <p:spPr>
          <a:xfrm>
            <a:off x="1627200" y="1965240"/>
            <a:ext cx="0" cy="255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1240" bIns="-212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正方形/長方形 143"/>
          <p:cNvSpPr/>
          <p:nvPr/>
        </p:nvSpPr>
        <p:spPr>
          <a:xfrm>
            <a:off x="1590840" y="1994040"/>
            <a:ext cx="71280" cy="1180800"/>
          </a:xfrm>
          <a:prstGeom prst="rect">
            <a:avLst/>
          </a:prstGeom>
          <a:solidFill>
            <a:srgbClr val="969696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正方形/長方形 146"/>
          <p:cNvSpPr/>
          <p:nvPr/>
        </p:nvSpPr>
        <p:spPr>
          <a:xfrm>
            <a:off x="1749600" y="3164040"/>
            <a:ext cx="71280" cy="1080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6000" bIns="-360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直線コネクタ 120"/>
          <p:cNvSpPr/>
          <p:nvPr/>
        </p:nvSpPr>
        <p:spPr>
          <a:xfrm>
            <a:off x="6507000" y="3105000"/>
            <a:ext cx="7164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直線コネクタ 130"/>
          <p:cNvSpPr/>
          <p:nvPr/>
        </p:nvSpPr>
        <p:spPr>
          <a:xfrm>
            <a:off x="6541920" y="3105000"/>
            <a:ext cx="0" cy="972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正方形/長方形 152"/>
          <p:cNvSpPr/>
          <p:nvPr/>
        </p:nvSpPr>
        <p:spPr>
          <a:xfrm>
            <a:off x="1908000" y="3138480"/>
            <a:ext cx="71640" cy="3636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正方形/長方形 154"/>
          <p:cNvSpPr/>
          <p:nvPr/>
        </p:nvSpPr>
        <p:spPr>
          <a:xfrm>
            <a:off x="2066760" y="3164040"/>
            <a:ext cx="71640" cy="1080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6000" bIns="-360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正方形/長方形 155"/>
          <p:cNvSpPr/>
          <p:nvPr/>
        </p:nvSpPr>
        <p:spPr>
          <a:xfrm>
            <a:off x="2224080" y="3164040"/>
            <a:ext cx="73080" cy="1080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6000" bIns="-360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正方形/長方形 156"/>
          <p:cNvSpPr/>
          <p:nvPr/>
        </p:nvSpPr>
        <p:spPr>
          <a:xfrm>
            <a:off x="2382840" y="3164040"/>
            <a:ext cx="73080" cy="1080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6000" bIns="-360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直線コネクタ 2694"/>
          <p:cNvSpPr/>
          <p:nvPr/>
        </p:nvSpPr>
        <p:spPr>
          <a:xfrm>
            <a:off x="1488960" y="1994040"/>
            <a:ext cx="7077240" cy="0"/>
          </a:xfrm>
          <a:prstGeom prst="line">
            <a:avLst/>
          </a:prstGeom>
          <a:ln w="324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直線コネクタ 184"/>
          <p:cNvSpPr/>
          <p:nvPr/>
        </p:nvSpPr>
        <p:spPr>
          <a:xfrm>
            <a:off x="1365120" y="1278000"/>
            <a:ext cx="12384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Rectangle 249"/>
          <p:cNvSpPr/>
          <p:nvPr/>
        </p:nvSpPr>
        <p:spPr>
          <a:xfrm>
            <a:off x="1168200" y="1209600"/>
            <a:ext cx="1609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1.6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Rectangle 249"/>
          <p:cNvSpPr/>
          <p:nvPr/>
        </p:nvSpPr>
        <p:spPr>
          <a:xfrm>
            <a:off x="1168200" y="1362240"/>
            <a:ext cx="1609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1.5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Rectangle 249"/>
          <p:cNvSpPr/>
          <p:nvPr/>
        </p:nvSpPr>
        <p:spPr>
          <a:xfrm>
            <a:off x="1168200" y="2521080"/>
            <a:ext cx="1609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0.5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Rectangle 249"/>
          <p:cNvSpPr/>
          <p:nvPr/>
        </p:nvSpPr>
        <p:spPr>
          <a:xfrm>
            <a:off x="1168200" y="1927080"/>
            <a:ext cx="1609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1.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Rectangle 249"/>
          <p:cNvSpPr/>
          <p:nvPr/>
        </p:nvSpPr>
        <p:spPr>
          <a:xfrm>
            <a:off x="1263600" y="3111480"/>
            <a:ext cx="648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正方形/長方形 191"/>
          <p:cNvSpPr/>
          <p:nvPr/>
        </p:nvSpPr>
        <p:spPr>
          <a:xfrm>
            <a:off x="2700360" y="3164040"/>
            <a:ext cx="71280" cy="1080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6000" bIns="-360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正方形/長方形 193"/>
          <p:cNvSpPr/>
          <p:nvPr/>
        </p:nvSpPr>
        <p:spPr>
          <a:xfrm>
            <a:off x="3176640" y="3164040"/>
            <a:ext cx="71280" cy="1080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6000" bIns="-360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正方形/長方形 197"/>
          <p:cNvSpPr/>
          <p:nvPr/>
        </p:nvSpPr>
        <p:spPr>
          <a:xfrm>
            <a:off x="4444920" y="3149640"/>
            <a:ext cx="71640" cy="2520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1600" bIns="-216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正方形/長方形 199"/>
          <p:cNvSpPr/>
          <p:nvPr/>
        </p:nvSpPr>
        <p:spPr>
          <a:xfrm>
            <a:off x="5079960" y="3164040"/>
            <a:ext cx="71640" cy="1080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6000" bIns="-360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正方形/長方形 209"/>
          <p:cNvSpPr/>
          <p:nvPr/>
        </p:nvSpPr>
        <p:spPr>
          <a:xfrm>
            <a:off x="3651120" y="3164040"/>
            <a:ext cx="73080" cy="1080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6000" bIns="-360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正方形/長方形 211"/>
          <p:cNvSpPr/>
          <p:nvPr/>
        </p:nvSpPr>
        <p:spPr>
          <a:xfrm>
            <a:off x="4286160" y="3164040"/>
            <a:ext cx="71640" cy="1080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6000" bIns="-360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正方形/長方形 214"/>
          <p:cNvSpPr/>
          <p:nvPr/>
        </p:nvSpPr>
        <p:spPr>
          <a:xfrm>
            <a:off x="5237280" y="3164040"/>
            <a:ext cx="73080" cy="1080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6000" bIns="-360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正方形/長方形 218"/>
          <p:cNvSpPr/>
          <p:nvPr/>
        </p:nvSpPr>
        <p:spPr>
          <a:xfrm>
            <a:off x="6507000" y="3117960"/>
            <a:ext cx="71640" cy="5688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0080" bIns="1008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正方形/長方形 220"/>
          <p:cNvSpPr/>
          <p:nvPr/>
        </p:nvSpPr>
        <p:spPr>
          <a:xfrm>
            <a:off x="7458120" y="1343160"/>
            <a:ext cx="71280" cy="183168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直線コネクタ 227"/>
          <p:cNvSpPr/>
          <p:nvPr/>
        </p:nvSpPr>
        <p:spPr>
          <a:xfrm>
            <a:off x="7458120" y="1300320"/>
            <a:ext cx="7128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直線コネクタ 228"/>
          <p:cNvSpPr/>
          <p:nvPr/>
        </p:nvSpPr>
        <p:spPr>
          <a:xfrm>
            <a:off x="7494480" y="1300320"/>
            <a:ext cx="0" cy="428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Text Box 3"/>
          <p:cNvSpPr/>
          <p:nvPr/>
        </p:nvSpPr>
        <p:spPr>
          <a:xfrm rot="16200000">
            <a:off x="1418040" y="3423960"/>
            <a:ext cx="4150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</a:rPr>
              <a:t>Esophagus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Text Box 3"/>
          <p:cNvSpPr/>
          <p:nvPr/>
        </p:nvSpPr>
        <p:spPr>
          <a:xfrm rot="16200000">
            <a:off x="1638360" y="3366000"/>
            <a:ext cx="2919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</a:rPr>
              <a:t>KYSE3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Text Box 3"/>
          <p:cNvSpPr/>
          <p:nvPr/>
        </p:nvSpPr>
        <p:spPr>
          <a:xfrm rot="16200000">
            <a:off x="1797120" y="3366000"/>
            <a:ext cx="2919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</a:rPr>
              <a:t>KYSE7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Text Box 3"/>
          <p:cNvSpPr/>
          <p:nvPr/>
        </p:nvSpPr>
        <p:spPr>
          <a:xfrm rot="16200000">
            <a:off x="1934640" y="3388680"/>
            <a:ext cx="3344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</a:rPr>
              <a:t>KYSE11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Text Box 3"/>
          <p:cNvSpPr/>
          <p:nvPr/>
        </p:nvSpPr>
        <p:spPr>
          <a:xfrm rot="16200000">
            <a:off x="2093400" y="3388680"/>
            <a:ext cx="3344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</a:rPr>
              <a:t>KYSE14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Text Box 3"/>
          <p:cNvSpPr/>
          <p:nvPr/>
        </p:nvSpPr>
        <p:spPr>
          <a:xfrm rot="16200000">
            <a:off x="2252160" y="3388680"/>
            <a:ext cx="3344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</a:rPr>
              <a:t>KYSE15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Text Box 3"/>
          <p:cNvSpPr/>
          <p:nvPr/>
        </p:nvSpPr>
        <p:spPr>
          <a:xfrm rot="16200000">
            <a:off x="2410920" y="3388680"/>
            <a:ext cx="3344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</a:rPr>
              <a:t>KYSE17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Text Box 3"/>
          <p:cNvSpPr/>
          <p:nvPr/>
        </p:nvSpPr>
        <p:spPr>
          <a:xfrm rot="16200000">
            <a:off x="2569320" y="3388680"/>
            <a:ext cx="3344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</a:rPr>
              <a:t>KYSE18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Text Box 3"/>
          <p:cNvSpPr/>
          <p:nvPr/>
        </p:nvSpPr>
        <p:spPr>
          <a:xfrm rot="16200000">
            <a:off x="2728080" y="3388680"/>
            <a:ext cx="3344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</a:rPr>
              <a:t>KYSE19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Text Box 3"/>
          <p:cNvSpPr/>
          <p:nvPr/>
        </p:nvSpPr>
        <p:spPr>
          <a:xfrm rot="16200000">
            <a:off x="2886840" y="3388680"/>
            <a:ext cx="3344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</a:rPr>
              <a:t>KYSE20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Text Box 3"/>
          <p:cNvSpPr/>
          <p:nvPr/>
        </p:nvSpPr>
        <p:spPr>
          <a:xfrm rot="16200000">
            <a:off x="3044160" y="3388680"/>
            <a:ext cx="3344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</a:rPr>
              <a:t>KYSE22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Text Box 3"/>
          <p:cNvSpPr/>
          <p:nvPr/>
        </p:nvSpPr>
        <p:spPr>
          <a:xfrm rot="16200000">
            <a:off x="3202920" y="3388680"/>
            <a:ext cx="3344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</a:rPr>
              <a:t>KYSE27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Text Box 3"/>
          <p:cNvSpPr/>
          <p:nvPr/>
        </p:nvSpPr>
        <p:spPr>
          <a:xfrm rot="16200000">
            <a:off x="3361680" y="3388680"/>
            <a:ext cx="3344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</a:rPr>
              <a:t>KYSE35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Text Box 3"/>
          <p:cNvSpPr/>
          <p:nvPr/>
        </p:nvSpPr>
        <p:spPr>
          <a:xfrm rot="16200000">
            <a:off x="3520440" y="3388680"/>
            <a:ext cx="3344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</a:rPr>
              <a:t>KYSE41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Text Box 3"/>
          <p:cNvSpPr/>
          <p:nvPr/>
        </p:nvSpPr>
        <p:spPr>
          <a:xfrm rot="16200000">
            <a:off x="3679200" y="3388680"/>
            <a:ext cx="3344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</a:rPr>
              <a:t>KYSE45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Text Box 3"/>
          <p:cNvSpPr/>
          <p:nvPr/>
        </p:nvSpPr>
        <p:spPr>
          <a:xfrm rot="16200000">
            <a:off x="3837960" y="3388680"/>
            <a:ext cx="3344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</a:rPr>
              <a:t>KYSE51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Text Box 3"/>
          <p:cNvSpPr/>
          <p:nvPr/>
        </p:nvSpPr>
        <p:spPr>
          <a:xfrm rot="16200000">
            <a:off x="3996720" y="3388680"/>
            <a:ext cx="3344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</a:rPr>
              <a:t>KYSE52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Text Box 3"/>
          <p:cNvSpPr/>
          <p:nvPr/>
        </p:nvSpPr>
        <p:spPr>
          <a:xfrm rot="16200000">
            <a:off x="4155480" y="3388680"/>
            <a:ext cx="3344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</a:rPr>
              <a:t>KYSE59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Text Box 3"/>
          <p:cNvSpPr/>
          <p:nvPr/>
        </p:nvSpPr>
        <p:spPr>
          <a:xfrm rot="16200000">
            <a:off x="4314240" y="3388680"/>
            <a:ext cx="3344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</a:rPr>
              <a:t>KYSE77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Text Box 3"/>
          <p:cNvSpPr/>
          <p:nvPr/>
        </p:nvSpPr>
        <p:spPr>
          <a:xfrm rot="16200000">
            <a:off x="4471200" y="3388680"/>
            <a:ext cx="3344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</a:rPr>
              <a:t>KYSE79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Text Box 3"/>
          <p:cNvSpPr/>
          <p:nvPr/>
        </p:nvSpPr>
        <p:spPr>
          <a:xfrm rot="16200000">
            <a:off x="4629960" y="3388680"/>
            <a:ext cx="3344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</a:rPr>
              <a:t>KYSE85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Text Box 3"/>
          <p:cNvSpPr/>
          <p:nvPr/>
        </p:nvSpPr>
        <p:spPr>
          <a:xfrm rot="16200000">
            <a:off x="4788720" y="3388680"/>
            <a:ext cx="3344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</a:rPr>
              <a:t>KYSE89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Text Box 3"/>
          <p:cNvSpPr/>
          <p:nvPr/>
        </p:nvSpPr>
        <p:spPr>
          <a:xfrm rot="16200000">
            <a:off x="4947480" y="3388680"/>
            <a:ext cx="3344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</a:rPr>
              <a:t>KYSE96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Text Box 3"/>
          <p:cNvSpPr/>
          <p:nvPr/>
        </p:nvSpPr>
        <p:spPr>
          <a:xfrm rot="16200000">
            <a:off x="5084640" y="3409920"/>
            <a:ext cx="37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</a:rPr>
              <a:t>KYSE117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Text Box 3"/>
          <p:cNvSpPr/>
          <p:nvPr/>
        </p:nvSpPr>
        <p:spPr>
          <a:xfrm rot="16200000">
            <a:off x="5243400" y="3409920"/>
            <a:ext cx="37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</a:rPr>
              <a:t>KYSE119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Text Box 3"/>
          <p:cNvSpPr/>
          <p:nvPr/>
        </p:nvSpPr>
        <p:spPr>
          <a:xfrm rot="16200000">
            <a:off x="5402160" y="3409920"/>
            <a:ext cx="37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</a:rPr>
              <a:t>KYSE124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Text Box 3"/>
          <p:cNvSpPr/>
          <p:nvPr/>
        </p:nvSpPr>
        <p:spPr>
          <a:xfrm rot="16200000">
            <a:off x="5560920" y="3409920"/>
            <a:ext cx="37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</a:rPr>
              <a:t>KYSE125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Text Box 3"/>
          <p:cNvSpPr/>
          <p:nvPr/>
        </p:nvSpPr>
        <p:spPr>
          <a:xfrm rot="16200000">
            <a:off x="5719680" y="3409920"/>
            <a:ext cx="37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</a:rPr>
              <a:t>KYSE126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Text Box 3"/>
          <p:cNvSpPr/>
          <p:nvPr/>
        </p:nvSpPr>
        <p:spPr>
          <a:xfrm rot="16200000">
            <a:off x="5878440" y="3409920"/>
            <a:ext cx="37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</a:rPr>
              <a:t>KYSE144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Text Box 3"/>
          <p:cNvSpPr/>
          <p:nvPr/>
        </p:nvSpPr>
        <p:spPr>
          <a:xfrm rot="16200000">
            <a:off x="6035760" y="3409920"/>
            <a:ext cx="37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</a:rPr>
              <a:t>KYSE227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Text Box 3"/>
          <p:cNvSpPr/>
          <p:nvPr/>
        </p:nvSpPr>
        <p:spPr>
          <a:xfrm rot="16200000">
            <a:off x="6194520" y="3409920"/>
            <a:ext cx="37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</a:rPr>
              <a:t>KYSE240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Text Box 3"/>
          <p:cNvSpPr/>
          <p:nvPr/>
        </p:nvSpPr>
        <p:spPr>
          <a:xfrm rot="16200000">
            <a:off x="6353280" y="3409920"/>
            <a:ext cx="37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</a:rPr>
              <a:t>KYSE265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Text Box 3"/>
          <p:cNvSpPr/>
          <p:nvPr/>
        </p:nvSpPr>
        <p:spPr>
          <a:xfrm rot="16200000">
            <a:off x="6630480" y="3288240"/>
            <a:ext cx="1407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</a:rPr>
              <a:t>TE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Text Box 3"/>
          <p:cNvSpPr/>
          <p:nvPr/>
        </p:nvSpPr>
        <p:spPr>
          <a:xfrm rot="16200000">
            <a:off x="6789240" y="3288240"/>
            <a:ext cx="1407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</a:rPr>
              <a:t>TE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Text Box 3"/>
          <p:cNvSpPr/>
          <p:nvPr/>
        </p:nvSpPr>
        <p:spPr>
          <a:xfrm rot="16200000">
            <a:off x="6948000" y="3288240"/>
            <a:ext cx="1407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</a:rPr>
              <a:t>TE4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Text Box 3"/>
          <p:cNvSpPr/>
          <p:nvPr/>
        </p:nvSpPr>
        <p:spPr>
          <a:xfrm rot="16200000">
            <a:off x="7106400" y="3288240"/>
            <a:ext cx="1407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</a:rPr>
              <a:t>TE5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Text Box 3"/>
          <p:cNvSpPr/>
          <p:nvPr/>
        </p:nvSpPr>
        <p:spPr>
          <a:xfrm rot="16200000">
            <a:off x="7265160" y="3288240"/>
            <a:ext cx="1407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</a:rPr>
              <a:t>TE6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Text Box 3"/>
          <p:cNvSpPr/>
          <p:nvPr/>
        </p:nvSpPr>
        <p:spPr>
          <a:xfrm rot="16200000">
            <a:off x="7423920" y="3288240"/>
            <a:ext cx="1407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</a:rPr>
              <a:t>TE8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Text Box 3"/>
          <p:cNvSpPr/>
          <p:nvPr/>
        </p:nvSpPr>
        <p:spPr>
          <a:xfrm rot="16200000">
            <a:off x="7581240" y="3288240"/>
            <a:ext cx="1407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</a:rPr>
              <a:t>TE9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Text Box 3"/>
          <p:cNvSpPr/>
          <p:nvPr/>
        </p:nvSpPr>
        <p:spPr>
          <a:xfrm rot="16200000">
            <a:off x="7718400" y="3310560"/>
            <a:ext cx="1836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</a:rPr>
              <a:t>TE1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Text Box 3"/>
          <p:cNvSpPr/>
          <p:nvPr/>
        </p:nvSpPr>
        <p:spPr>
          <a:xfrm rot="16200000">
            <a:off x="7877160" y="3310560"/>
            <a:ext cx="1836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</a:rPr>
              <a:t>TE1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Text Box 3"/>
          <p:cNvSpPr/>
          <p:nvPr/>
        </p:nvSpPr>
        <p:spPr>
          <a:xfrm rot="16200000">
            <a:off x="8035920" y="3310560"/>
            <a:ext cx="1836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</a:rPr>
              <a:t>TE1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Text Box 3"/>
          <p:cNvSpPr/>
          <p:nvPr/>
        </p:nvSpPr>
        <p:spPr>
          <a:xfrm rot="16200000">
            <a:off x="8194680" y="3310560"/>
            <a:ext cx="1836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</a:rPr>
              <a:t>TE14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Text Box 3"/>
          <p:cNvSpPr/>
          <p:nvPr/>
        </p:nvSpPr>
        <p:spPr>
          <a:xfrm rot="16200000">
            <a:off x="8353440" y="3310560"/>
            <a:ext cx="1836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</a:rPr>
              <a:t>TE15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直線コネクタ 279"/>
          <p:cNvSpPr/>
          <p:nvPr/>
        </p:nvSpPr>
        <p:spPr>
          <a:xfrm>
            <a:off x="4284720" y="3152880"/>
            <a:ext cx="7308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直線コネクタ 280"/>
          <p:cNvSpPr/>
          <p:nvPr/>
        </p:nvSpPr>
        <p:spPr>
          <a:xfrm>
            <a:off x="4321080" y="3152880"/>
            <a:ext cx="0" cy="111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正方形/長方形 281"/>
          <p:cNvSpPr/>
          <p:nvPr/>
        </p:nvSpPr>
        <p:spPr>
          <a:xfrm>
            <a:off x="3970440" y="3164040"/>
            <a:ext cx="71280" cy="1080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6000" bIns="-360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直線コネクタ 282"/>
          <p:cNvSpPr/>
          <p:nvPr/>
        </p:nvSpPr>
        <p:spPr>
          <a:xfrm>
            <a:off x="3968640" y="3152880"/>
            <a:ext cx="7164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直線コネクタ 283"/>
          <p:cNvSpPr/>
          <p:nvPr/>
        </p:nvSpPr>
        <p:spPr>
          <a:xfrm>
            <a:off x="4005360" y="3152880"/>
            <a:ext cx="0" cy="111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直線コネクタ 284"/>
          <p:cNvSpPr/>
          <p:nvPr/>
        </p:nvSpPr>
        <p:spPr>
          <a:xfrm>
            <a:off x="1908000" y="3111480"/>
            <a:ext cx="7164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直線コネクタ 285"/>
          <p:cNvSpPr/>
          <p:nvPr/>
        </p:nvSpPr>
        <p:spPr>
          <a:xfrm>
            <a:off x="1943280" y="3111480"/>
            <a:ext cx="0" cy="255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1240" bIns="-212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テキスト ボックス 251"/>
          <p:cNvSpPr/>
          <p:nvPr/>
        </p:nvSpPr>
        <p:spPr>
          <a:xfrm rot="16200000">
            <a:off x="235800" y="2043720"/>
            <a:ext cx="1395360" cy="36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HGSｺﾞｼｯｸE"/>
              </a:rPr>
              <a:t>Expression ratio of </a:t>
            </a:r>
            <a:r>
              <a:rPr b="1" i="1" lang="en-US" sz="800" spc="-1" strike="noStrike">
                <a:solidFill>
                  <a:srgbClr val="000000"/>
                </a:solidFill>
                <a:latin typeface="Arial"/>
                <a:ea typeface="HGSｺﾞｼｯｸE"/>
              </a:rPr>
              <a:t>miR-65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HGSｺﾞｼｯｸE"/>
              </a:rPr>
              <a:t>mRNA</a:t>
            </a:r>
            <a:r>
              <a:rPr b="1" i="1" lang="en-US" sz="800" spc="-1" strike="noStrike">
                <a:solidFill>
                  <a:srgbClr val="000000"/>
                </a:solidFill>
                <a:latin typeface="Arial"/>
                <a:ea typeface="HGSｺﾞｼｯｸE"/>
              </a:rPr>
              <a:t> 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  <a:ea typeface="HGSｺﾞｼｯｸE"/>
              </a:rPr>
              <a:t>in ESCC cell lin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HGSｺﾞｼｯｸE"/>
              </a:rPr>
              <a:t>relative to esophageal tissu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Rectangle 249"/>
          <p:cNvSpPr/>
          <p:nvPr/>
        </p:nvSpPr>
        <p:spPr>
          <a:xfrm>
            <a:off x="1168200" y="4923000"/>
            <a:ext cx="1609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3.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Rectangle 249"/>
          <p:cNvSpPr/>
          <p:nvPr/>
        </p:nvSpPr>
        <p:spPr>
          <a:xfrm>
            <a:off x="1168200" y="5483160"/>
            <a:ext cx="1609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1.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Rectangle 249"/>
          <p:cNvSpPr/>
          <p:nvPr/>
        </p:nvSpPr>
        <p:spPr>
          <a:xfrm>
            <a:off x="1168200" y="4068720"/>
            <a:ext cx="1609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6.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Rectangle 249"/>
          <p:cNvSpPr/>
          <p:nvPr/>
        </p:nvSpPr>
        <p:spPr>
          <a:xfrm>
            <a:off x="1263600" y="5765760"/>
            <a:ext cx="648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Text Box 3"/>
          <p:cNvSpPr/>
          <p:nvPr/>
        </p:nvSpPr>
        <p:spPr>
          <a:xfrm rot="16200000">
            <a:off x="1418040" y="6074280"/>
            <a:ext cx="4150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</a:rPr>
              <a:t>Esophagus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テキスト ボックス 251"/>
          <p:cNvSpPr/>
          <p:nvPr/>
        </p:nvSpPr>
        <p:spPr>
          <a:xfrm rot="16200000">
            <a:off x="235800" y="4800240"/>
            <a:ext cx="1395360" cy="36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HGSｺﾞｼｯｸE"/>
              </a:rPr>
              <a:t>Expression ratio of </a:t>
            </a:r>
            <a:r>
              <a:rPr b="1" i="1" lang="en-US" sz="800" spc="-1" strike="noStrike">
                <a:solidFill>
                  <a:srgbClr val="000000"/>
                </a:solidFill>
                <a:latin typeface="Arial"/>
                <a:ea typeface="HGSｺﾞｼｯｸE"/>
              </a:rPr>
              <a:t>miR-65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HGSｺﾞｼｯｸE"/>
              </a:rPr>
              <a:t>mRNA</a:t>
            </a:r>
            <a:r>
              <a:rPr b="1" i="1" lang="en-US" sz="800" spc="-1" strike="noStrike">
                <a:solidFill>
                  <a:srgbClr val="000000"/>
                </a:solidFill>
                <a:latin typeface="Arial"/>
                <a:ea typeface="HGSｺﾞｼｯｸE"/>
              </a:rPr>
              <a:t> 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  <a:ea typeface="HGSｺﾞｼｯｸE"/>
              </a:rPr>
              <a:t>in OSCC cell lin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HGSｺﾞｼｯｸE"/>
              </a:rPr>
              <a:t>relative to esophageal tissu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Rectangle 986"/>
          <p:cNvSpPr/>
          <p:nvPr/>
        </p:nvSpPr>
        <p:spPr>
          <a:xfrm rot="16200000">
            <a:off x="1647000" y="6007680"/>
            <a:ext cx="27792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b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Ca-9-2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Rectangle 987"/>
          <p:cNvSpPr/>
          <p:nvPr/>
        </p:nvSpPr>
        <p:spPr>
          <a:xfrm rot="16200000">
            <a:off x="1789560" y="6022440"/>
            <a:ext cx="3070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b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HO1-N-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Rectangle 988"/>
          <p:cNvSpPr/>
          <p:nvPr/>
        </p:nvSpPr>
        <p:spPr>
          <a:xfrm rot="16200000">
            <a:off x="1952640" y="6018120"/>
            <a:ext cx="2980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b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HOC31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Rectangle 989"/>
          <p:cNvSpPr/>
          <p:nvPr/>
        </p:nvSpPr>
        <p:spPr>
          <a:xfrm rot="16200000">
            <a:off x="2111400" y="6018120"/>
            <a:ext cx="2980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b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HOC815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Rectangle 990"/>
          <p:cNvSpPr/>
          <p:nvPr/>
        </p:nvSpPr>
        <p:spPr>
          <a:xfrm rot="16200000">
            <a:off x="2317680" y="5970240"/>
            <a:ext cx="2034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b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HSC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Rectangle 991"/>
          <p:cNvSpPr/>
          <p:nvPr/>
        </p:nvSpPr>
        <p:spPr>
          <a:xfrm rot="16200000">
            <a:off x="2476440" y="5970240"/>
            <a:ext cx="2034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b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HSC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Rectangle 992"/>
          <p:cNvSpPr/>
          <p:nvPr/>
        </p:nvSpPr>
        <p:spPr>
          <a:xfrm rot="16200000">
            <a:off x="2635200" y="5970240"/>
            <a:ext cx="2034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b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HSC4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Rectangle 993"/>
          <p:cNvSpPr/>
          <p:nvPr/>
        </p:nvSpPr>
        <p:spPr>
          <a:xfrm rot="16200000">
            <a:off x="2793960" y="5970240"/>
            <a:ext cx="2034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b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HSC5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Rectangle 994"/>
          <p:cNvSpPr/>
          <p:nvPr/>
        </p:nvSpPr>
        <p:spPr>
          <a:xfrm rot="16200000">
            <a:off x="2952720" y="5970240"/>
            <a:ext cx="2034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b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HSC6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Rectangle 995"/>
          <p:cNvSpPr/>
          <p:nvPr/>
        </p:nvSpPr>
        <p:spPr>
          <a:xfrm rot="16200000">
            <a:off x="3111480" y="5970240"/>
            <a:ext cx="2034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b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HSC7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Rectangle 996"/>
          <p:cNvSpPr/>
          <p:nvPr/>
        </p:nvSpPr>
        <p:spPr>
          <a:xfrm rot="16200000">
            <a:off x="3286800" y="5952960"/>
            <a:ext cx="16992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b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KON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Rectangle 997"/>
          <p:cNvSpPr/>
          <p:nvPr/>
        </p:nvSpPr>
        <p:spPr>
          <a:xfrm rot="16200000">
            <a:off x="3399120" y="6000480"/>
            <a:ext cx="2628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b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KOSC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Rectangle 998"/>
          <p:cNvSpPr/>
          <p:nvPr/>
        </p:nvSpPr>
        <p:spPr>
          <a:xfrm rot="16200000">
            <a:off x="3632760" y="5923440"/>
            <a:ext cx="11052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b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N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Rectangle 999"/>
          <p:cNvSpPr/>
          <p:nvPr/>
        </p:nvSpPr>
        <p:spPr>
          <a:xfrm rot="16200000">
            <a:off x="3763440" y="5950440"/>
            <a:ext cx="1666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b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OM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Rectangle 1000"/>
          <p:cNvSpPr/>
          <p:nvPr/>
        </p:nvSpPr>
        <p:spPr>
          <a:xfrm rot="16200000">
            <a:off x="3922200" y="5950440"/>
            <a:ext cx="1666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b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OM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Rectangle 1001"/>
          <p:cNvSpPr/>
          <p:nvPr/>
        </p:nvSpPr>
        <p:spPr>
          <a:xfrm rot="16200000">
            <a:off x="4062600" y="5970240"/>
            <a:ext cx="2034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b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SKN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Rectangle 1002"/>
          <p:cNvSpPr/>
          <p:nvPr/>
        </p:nvSpPr>
        <p:spPr>
          <a:xfrm rot="16200000">
            <a:off x="4403520" y="5944680"/>
            <a:ext cx="1530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b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TSU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Rectangle 1003"/>
          <p:cNvSpPr/>
          <p:nvPr/>
        </p:nvSpPr>
        <p:spPr>
          <a:xfrm rot="16200000">
            <a:off x="4587120" y="5918760"/>
            <a:ext cx="1029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b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Z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Rectangle 1002"/>
          <p:cNvSpPr/>
          <p:nvPr/>
        </p:nvSpPr>
        <p:spPr>
          <a:xfrm rot="16200000">
            <a:off x="4244760" y="5946480"/>
            <a:ext cx="1562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b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SAS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直線コネクタ 288"/>
          <p:cNvSpPr/>
          <p:nvPr/>
        </p:nvSpPr>
        <p:spPr>
          <a:xfrm>
            <a:off x="1365120" y="4989600"/>
            <a:ext cx="12384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直線コネクタ 289"/>
          <p:cNvSpPr/>
          <p:nvPr/>
        </p:nvSpPr>
        <p:spPr>
          <a:xfrm>
            <a:off x="1365120" y="5272200"/>
            <a:ext cx="12384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直線コネクタ 290"/>
          <p:cNvSpPr/>
          <p:nvPr/>
        </p:nvSpPr>
        <p:spPr>
          <a:xfrm>
            <a:off x="1365120" y="5551560"/>
            <a:ext cx="12384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直線コネクタ 291"/>
          <p:cNvSpPr/>
          <p:nvPr/>
        </p:nvSpPr>
        <p:spPr>
          <a:xfrm>
            <a:off x="1365120" y="5829480"/>
            <a:ext cx="12384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直線コネクタ 292"/>
          <p:cNvSpPr/>
          <p:nvPr/>
        </p:nvSpPr>
        <p:spPr>
          <a:xfrm>
            <a:off x="1590840" y="5545080"/>
            <a:ext cx="7128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直線コネクタ 293"/>
          <p:cNvSpPr/>
          <p:nvPr/>
        </p:nvSpPr>
        <p:spPr>
          <a:xfrm>
            <a:off x="1627200" y="5545080"/>
            <a:ext cx="0" cy="792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正方形/長方形 294"/>
          <p:cNvSpPr/>
          <p:nvPr/>
        </p:nvSpPr>
        <p:spPr>
          <a:xfrm>
            <a:off x="1590840" y="5551560"/>
            <a:ext cx="71280" cy="277920"/>
          </a:xfrm>
          <a:prstGeom prst="rect">
            <a:avLst/>
          </a:prstGeom>
          <a:solidFill>
            <a:srgbClr val="969696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直線コネクタ 2694"/>
          <p:cNvSpPr/>
          <p:nvPr/>
        </p:nvSpPr>
        <p:spPr>
          <a:xfrm>
            <a:off x="1488960" y="5551560"/>
            <a:ext cx="3260880" cy="0"/>
          </a:xfrm>
          <a:prstGeom prst="line">
            <a:avLst/>
          </a:prstGeom>
          <a:ln w="324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正方形/長方形 309"/>
          <p:cNvSpPr/>
          <p:nvPr/>
        </p:nvSpPr>
        <p:spPr>
          <a:xfrm>
            <a:off x="2860560" y="5821200"/>
            <a:ext cx="71640" cy="828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520" bIns="-385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正方形/長方形 310"/>
          <p:cNvSpPr/>
          <p:nvPr/>
        </p:nvSpPr>
        <p:spPr>
          <a:xfrm>
            <a:off x="3017880" y="5781600"/>
            <a:ext cx="71280" cy="4788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080" bIns="108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正方形/長方形 313"/>
          <p:cNvSpPr/>
          <p:nvPr/>
        </p:nvSpPr>
        <p:spPr>
          <a:xfrm>
            <a:off x="3651120" y="5826240"/>
            <a:ext cx="73080" cy="324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正方形/長方形 317"/>
          <p:cNvSpPr/>
          <p:nvPr/>
        </p:nvSpPr>
        <p:spPr>
          <a:xfrm>
            <a:off x="3178080" y="4633920"/>
            <a:ext cx="71640" cy="119556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直線コネクタ 318"/>
          <p:cNvSpPr/>
          <p:nvPr/>
        </p:nvSpPr>
        <p:spPr>
          <a:xfrm>
            <a:off x="3178080" y="4303800"/>
            <a:ext cx="7164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直線コネクタ 319"/>
          <p:cNvSpPr/>
          <p:nvPr/>
        </p:nvSpPr>
        <p:spPr>
          <a:xfrm>
            <a:off x="3213000" y="4303800"/>
            <a:ext cx="0" cy="32868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直線コネクタ 391"/>
          <p:cNvSpPr/>
          <p:nvPr/>
        </p:nvSpPr>
        <p:spPr>
          <a:xfrm>
            <a:off x="2859120" y="5818320"/>
            <a:ext cx="7128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直線コネクタ 392"/>
          <p:cNvSpPr/>
          <p:nvPr/>
        </p:nvSpPr>
        <p:spPr>
          <a:xfrm>
            <a:off x="2895480" y="5818320"/>
            <a:ext cx="0" cy="288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正方形/長方形 393"/>
          <p:cNvSpPr/>
          <p:nvPr/>
        </p:nvSpPr>
        <p:spPr>
          <a:xfrm>
            <a:off x="3489480" y="5821200"/>
            <a:ext cx="71280" cy="828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520" bIns="-385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直線コネクタ 394"/>
          <p:cNvSpPr/>
          <p:nvPr/>
        </p:nvSpPr>
        <p:spPr>
          <a:xfrm>
            <a:off x="3490920" y="5829480"/>
            <a:ext cx="7128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直線コネクタ 395"/>
          <p:cNvSpPr/>
          <p:nvPr/>
        </p:nvSpPr>
        <p:spPr>
          <a:xfrm>
            <a:off x="3527280" y="5826240"/>
            <a:ext cx="0" cy="32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正方形/長方形 396"/>
          <p:cNvSpPr/>
          <p:nvPr/>
        </p:nvSpPr>
        <p:spPr>
          <a:xfrm>
            <a:off x="3336840" y="5796000"/>
            <a:ext cx="71640" cy="3348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3320" bIns="-133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直線コネクタ 399"/>
          <p:cNvSpPr/>
          <p:nvPr/>
        </p:nvSpPr>
        <p:spPr>
          <a:xfrm>
            <a:off x="3489480" y="5816520"/>
            <a:ext cx="7128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直線コネクタ 400"/>
          <p:cNvSpPr/>
          <p:nvPr/>
        </p:nvSpPr>
        <p:spPr>
          <a:xfrm>
            <a:off x="3524400" y="5816520"/>
            <a:ext cx="0" cy="32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直線コネクタ 401"/>
          <p:cNvSpPr/>
          <p:nvPr/>
        </p:nvSpPr>
        <p:spPr>
          <a:xfrm>
            <a:off x="3336840" y="5789520"/>
            <a:ext cx="7164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直線コネクタ 402"/>
          <p:cNvSpPr/>
          <p:nvPr/>
        </p:nvSpPr>
        <p:spPr>
          <a:xfrm>
            <a:off x="3371760" y="5789520"/>
            <a:ext cx="0" cy="468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正方形/長方形 403"/>
          <p:cNvSpPr/>
          <p:nvPr/>
        </p:nvSpPr>
        <p:spPr>
          <a:xfrm>
            <a:off x="4603680" y="5826240"/>
            <a:ext cx="71640" cy="324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直線コネクタ 404"/>
          <p:cNvSpPr/>
          <p:nvPr/>
        </p:nvSpPr>
        <p:spPr>
          <a:xfrm>
            <a:off x="4602240" y="5821200"/>
            <a:ext cx="7308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直線コネクタ 405"/>
          <p:cNvSpPr/>
          <p:nvPr/>
        </p:nvSpPr>
        <p:spPr>
          <a:xfrm>
            <a:off x="4638600" y="5821200"/>
            <a:ext cx="0" cy="32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正方形/長方形 406"/>
          <p:cNvSpPr/>
          <p:nvPr/>
        </p:nvSpPr>
        <p:spPr>
          <a:xfrm>
            <a:off x="4127400" y="5824440"/>
            <a:ext cx="73080" cy="504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正方形/長方形 407"/>
          <p:cNvSpPr/>
          <p:nvPr/>
        </p:nvSpPr>
        <p:spPr>
          <a:xfrm>
            <a:off x="4284720" y="5824440"/>
            <a:ext cx="73080" cy="504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直線コネクタ 409"/>
          <p:cNvSpPr/>
          <p:nvPr/>
        </p:nvSpPr>
        <p:spPr>
          <a:xfrm>
            <a:off x="1365120" y="4705200"/>
            <a:ext cx="12384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直線コネクタ 410"/>
          <p:cNvSpPr/>
          <p:nvPr/>
        </p:nvSpPr>
        <p:spPr>
          <a:xfrm>
            <a:off x="1365120" y="4421160"/>
            <a:ext cx="12384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直線コネクタ 411"/>
          <p:cNvSpPr/>
          <p:nvPr/>
        </p:nvSpPr>
        <p:spPr>
          <a:xfrm>
            <a:off x="1365120" y="4137120"/>
            <a:ext cx="12384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Rectangle 4"/>
          <p:cNvSpPr/>
          <p:nvPr/>
        </p:nvSpPr>
        <p:spPr>
          <a:xfrm>
            <a:off x="8102160" y="169920"/>
            <a:ext cx="163440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Times New Roman"/>
              </a:rPr>
              <a:t>Harazono Y </a:t>
            </a:r>
            <a:r>
              <a:rPr b="1" i="1" lang="en-US" sz="1600" spc="-1" strike="noStrike">
                <a:solidFill>
                  <a:srgbClr val="000000"/>
                </a:solidFill>
                <a:latin typeface="Arial"/>
                <a:ea typeface="Times New Roman"/>
              </a:rPr>
              <a:t>et al.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正方形/長方形 287"/>
          <p:cNvSpPr/>
          <p:nvPr/>
        </p:nvSpPr>
        <p:spPr>
          <a:xfrm>
            <a:off x="1488960" y="4137120"/>
            <a:ext cx="3262320" cy="1692360"/>
          </a:xfrm>
          <a:prstGeom prst="rect">
            <a:avLst/>
          </a:prstGeom>
          <a:noFill/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テキスト ボックス 251"/>
          <p:cNvSpPr/>
          <p:nvPr/>
        </p:nvSpPr>
        <p:spPr>
          <a:xfrm rot="16200000">
            <a:off x="5349600" y="4739400"/>
            <a:ext cx="1395360" cy="48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HGSｺﾞｼｯｸE"/>
              </a:rPr>
              <a:t>Expression ratio of </a:t>
            </a:r>
            <a:r>
              <a:rPr b="1" i="1" lang="en-US" sz="800" spc="-1" strike="noStrike">
                <a:solidFill>
                  <a:srgbClr val="000000"/>
                </a:solidFill>
                <a:latin typeface="Arial"/>
                <a:ea typeface="HGSｺﾞｼｯｸE"/>
              </a:rPr>
              <a:t>miR-65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800" spc="-1" strike="noStrike">
                <a:solidFill>
                  <a:srgbClr val="000000"/>
                </a:solidFill>
                <a:latin typeface="Arial"/>
                <a:ea typeface="HGSｺﾞｼｯｸE"/>
              </a:rPr>
              <a:t> 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  <a:ea typeface="HGSｺﾞｼｯｸE"/>
              </a:rPr>
              <a:t>in normal breast and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HGSｺﾞｼｯｸE"/>
              </a:rPr>
              <a:t>Breast cancer cell lin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HGSｺﾞｼｯｸE"/>
              </a:rPr>
              <a:t>relative to esophageal tissu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Rectangle 249"/>
          <p:cNvSpPr/>
          <p:nvPr/>
        </p:nvSpPr>
        <p:spPr>
          <a:xfrm>
            <a:off x="6384600" y="4354560"/>
            <a:ext cx="1609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1.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Rectangle 249"/>
          <p:cNvSpPr/>
          <p:nvPr/>
        </p:nvSpPr>
        <p:spPr>
          <a:xfrm>
            <a:off x="6384600" y="5057640"/>
            <a:ext cx="1609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0.5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Rectangle 249"/>
          <p:cNvSpPr/>
          <p:nvPr/>
        </p:nvSpPr>
        <p:spPr>
          <a:xfrm>
            <a:off x="6480000" y="5762520"/>
            <a:ext cx="648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Text Box 3"/>
          <p:cNvSpPr/>
          <p:nvPr/>
        </p:nvSpPr>
        <p:spPr>
          <a:xfrm rot="16200000">
            <a:off x="6640920" y="6073560"/>
            <a:ext cx="4150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</a:rPr>
              <a:t>Esophagus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Text Box 3"/>
          <p:cNvSpPr/>
          <p:nvPr/>
        </p:nvSpPr>
        <p:spPr>
          <a:xfrm rot="16200000">
            <a:off x="6764760" y="6161400"/>
            <a:ext cx="5828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</a:rPr>
              <a:t>Mammary gland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Text Box 3"/>
          <p:cNvSpPr/>
          <p:nvPr/>
        </p:nvSpPr>
        <p:spPr>
          <a:xfrm rot="16200000">
            <a:off x="7110720" y="6022440"/>
            <a:ext cx="3070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</a:rPr>
              <a:t>MCF10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Text Box 3"/>
          <p:cNvSpPr/>
          <p:nvPr/>
        </p:nvSpPr>
        <p:spPr>
          <a:xfrm rot="16200000">
            <a:off x="7367400" y="5972040"/>
            <a:ext cx="20952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</a:rPr>
              <a:t>MCF7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Text Box 3"/>
          <p:cNvSpPr/>
          <p:nvPr/>
        </p:nvSpPr>
        <p:spPr>
          <a:xfrm rot="16200000">
            <a:off x="7441920" y="6106320"/>
            <a:ext cx="4730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</a:rPr>
              <a:t>MDA-MB-23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Text Box 3"/>
          <p:cNvSpPr/>
          <p:nvPr/>
        </p:nvSpPr>
        <p:spPr>
          <a:xfrm rot="16200000">
            <a:off x="3287880" y="3006360"/>
            <a:ext cx="1652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UD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Text Box 3"/>
          <p:cNvSpPr/>
          <p:nvPr/>
        </p:nvSpPr>
        <p:spPr>
          <a:xfrm rot="16200000">
            <a:off x="4080240" y="3006360"/>
            <a:ext cx="1652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UD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Text Box 3"/>
          <p:cNvSpPr/>
          <p:nvPr/>
        </p:nvSpPr>
        <p:spPr>
          <a:xfrm rot="16200000">
            <a:off x="4556520" y="3006360"/>
            <a:ext cx="1652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UD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Text Box 3"/>
          <p:cNvSpPr/>
          <p:nvPr/>
        </p:nvSpPr>
        <p:spPr>
          <a:xfrm rot="16200000">
            <a:off x="5666040" y="3006360"/>
            <a:ext cx="1652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UD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Text Box 3"/>
          <p:cNvSpPr/>
          <p:nvPr/>
        </p:nvSpPr>
        <p:spPr>
          <a:xfrm rot="16200000">
            <a:off x="8361720" y="3006360"/>
            <a:ext cx="1652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UD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Text Box 3"/>
          <p:cNvSpPr/>
          <p:nvPr/>
        </p:nvSpPr>
        <p:spPr>
          <a:xfrm rot="16200000">
            <a:off x="8204400" y="3006360"/>
            <a:ext cx="1652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UD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Text Box 3"/>
          <p:cNvSpPr/>
          <p:nvPr/>
        </p:nvSpPr>
        <p:spPr>
          <a:xfrm rot="16200000">
            <a:off x="8047440" y="3006360"/>
            <a:ext cx="1652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UD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Rectangle 249"/>
          <p:cNvSpPr/>
          <p:nvPr/>
        </p:nvSpPr>
        <p:spPr>
          <a:xfrm>
            <a:off x="6384600" y="4067280"/>
            <a:ext cx="1609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1.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10" name="グループ化 1"/>
          <p:cNvGrpSpPr/>
          <p:nvPr/>
        </p:nvGrpSpPr>
        <p:grpSpPr>
          <a:xfrm>
            <a:off x="6581880" y="4137120"/>
            <a:ext cx="1253880" cy="1692360"/>
            <a:chOff x="6581880" y="4137120"/>
            <a:chExt cx="1253880" cy="1692360"/>
          </a:xfrm>
        </p:grpSpPr>
        <p:sp>
          <p:nvSpPr>
            <p:cNvPr id="211" name="正方形/長方形 147"/>
            <p:cNvSpPr/>
            <p:nvPr/>
          </p:nvSpPr>
          <p:spPr>
            <a:xfrm>
              <a:off x="6705360" y="4137120"/>
              <a:ext cx="1130400" cy="1692360"/>
            </a:xfrm>
            <a:prstGeom prst="rect">
              <a:avLst/>
            </a:prstGeom>
            <a:noFill/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2" name="直線コネクタ 150"/>
            <p:cNvSpPr/>
            <p:nvPr/>
          </p:nvSpPr>
          <p:spPr>
            <a:xfrm>
              <a:off x="6581880" y="4419720"/>
              <a:ext cx="12348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3" name="直線コネクタ 153"/>
            <p:cNvSpPr/>
            <p:nvPr/>
          </p:nvSpPr>
          <p:spPr>
            <a:xfrm>
              <a:off x="6581880" y="5124600"/>
              <a:ext cx="12348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4" name="直線コネクタ 157"/>
            <p:cNvSpPr/>
            <p:nvPr/>
          </p:nvSpPr>
          <p:spPr>
            <a:xfrm>
              <a:off x="6581880" y="5829480"/>
              <a:ext cx="12348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5" name="直線コネクタ 2694"/>
            <p:cNvSpPr/>
            <p:nvPr/>
          </p:nvSpPr>
          <p:spPr>
            <a:xfrm>
              <a:off x="6705360" y="4419720"/>
              <a:ext cx="1130400" cy="0"/>
            </a:xfrm>
            <a:prstGeom prst="line">
              <a:avLst/>
            </a:prstGeom>
            <a:ln w="324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6" name="正方形/長方形 151"/>
            <p:cNvSpPr/>
            <p:nvPr/>
          </p:nvSpPr>
          <p:spPr>
            <a:xfrm>
              <a:off x="6813360" y="4419720"/>
              <a:ext cx="71280" cy="1409760"/>
            </a:xfrm>
            <a:prstGeom prst="rect">
              <a:avLst/>
            </a:prstGeom>
            <a:solidFill>
              <a:srgbClr val="969696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7" name="直線コネクタ 161"/>
            <p:cNvSpPr/>
            <p:nvPr/>
          </p:nvSpPr>
          <p:spPr>
            <a:xfrm>
              <a:off x="6815160" y="4389480"/>
              <a:ext cx="7128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8" name="直線コネクタ 162"/>
            <p:cNvSpPr/>
            <p:nvPr/>
          </p:nvSpPr>
          <p:spPr>
            <a:xfrm>
              <a:off x="6850080" y="4389480"/>
              <a:ext cx="0" cy="2988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9" name="正方形/長方形 163"/>
            <p:cNvSpPr/>
            <p:nvPr/>
          </p:nvSpPr>
          <p:spPr>
            <a:xfrm>
              <a:off x="7021440" y="5648760"/>
              <a:ext cx="71280" cy="180720"/>
            </a:xfrm>
            <a:prstGeom prst="rect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0" name="直線コネクタ 164"/>
            <p:cNvSpPr/>
            <p:nvPr/>
          </p:nvSpPr>
          <p:spPr>
            <a:xfrm>
              <a:off x="7021440" y="5632920"/>
              <a:ext cx="7128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1" name="直線コネクタ 165"/>
            <p:cNvSpPr/>
            <p:nvPr/>
          </p:nvSpPr>
          <p:spPr>
            <a:xfrm>
              <a:off x="7056360" y="5632920"/>
              <a:ext cx="0" cy="158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2" name="正方形/長方形 170"/>
            <p:cNvSpPr/>
            <p:nvPr/>
          </p:nvSpPr>
          <p:spPr>
            <a:xfrm>
              <a:off x="7229520" y="5759640"/>
              <a:ext cx="71280" cy="69840"/>
            </a:xfrm>
            <a:prstGeom prst="rect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3" name="正方形/長方形 174"/>
            <p:cNvSpPr/>
            <p:nvPr/>
          </p:nvSpPr>
          <p:spPr>
            <a:xfrm>
              <a:off x="7437600" y="5446800"/>
              <a:ext cx="71280" cy="382680"/>
            </a:xfrm>
            <a:prstGeom prst="rect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4" name="直線コネクタ 187"/>
            <p:cNvSpPr/>
            <p:nvPr/>
          </p:nvSpPr>
          <p:spPr>
            <a:xfrm>
              <a:off x="7230960" y="5743800"/>
              <a:ext cx="7128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5" name="直線コネクタ 188"/>
            <p:cNvSpPr/>
            <p:nvPr/>
          </p:nvSpPr>
          <p:spPr>
            <a:xfrm>
              <a:off x="7265880" y="5743800"/>
              <a:ext cx="0" cy="158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6" name="Text Box 3"/>
            <p:cNvSpPr/>
            <p:nvPr/>
          </p:nvSpPr>
          <p:spPr>
            <a:xfrm rot="16200000">
              <a:off x="7596360" y="5649840"/>
              <a:ext cx="1652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UD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7" name="直線コネクタ 179"/>
            <p:cNvSpPr/>
            <p:nvPr/>
          </p:nvSpPr>
          <p:spPr>
            <a:xfrm>
              <a:off x="6581880" y="4137120"/>
              <a:ext cx="12348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28" name="Text Box 3"/>
          <p:cNvSpPr/>
          <p:nvPr/>
        </p:nvSpPr>
        <p:spPr>
          <a:xfrm>
            <a:off x="430560" y="644400"/>
            <a:ext cx="14688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Text Box 3"/>
          <p:cNvSpPr/>
          <p:nvPr/>
        </p:nvSpPr>
        <p:spPr>
          <a:xfrm>
            <a:off x="430560" y="3954600"/>
            <a:ext cx="14688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Text Box 3"/>
          <p:cNvSpPr/>
          <p:nvPr/>
        </p:nvSpPr>
        <p:spPr>
          <a:xfrm>
            <a:off x="5505840" y="3954600"/>
            <a:ext cx="14688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02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4-15T04:20:50Z</dcterms:created>
  <dc:creator>yosuke harazono</dc:creator>
  <dc:description/>
  <dc:language>en-US</dc:language>
  <cp:lastModifiedBy>MCG</cp:lastModifiedBy>
  <cp:lastPrinted>2012-08-28T05:49:27Z</cp:lastPrinted>
  <dcterms:modified xsi:type="dcterms:W3CDTF">2013-03-12T03:29:42Z</dcterms:modified>
  <cp:revision>277</cp:revision>
  <dc:subject/>
  <dc:title>PowerPoint プレゼンテーション</dc:title>
</cp:coreProperties>
</file>